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53" autoAdjust="0"/>
    <p:restoredTop sz="94660"/>
  </p:normalViewPr>
  <p:slideViewPr>
    <p:cSldViewPr>
      <p:cViewPr>
        <p:scale>
          <a:sx n="100" d="100"/>
          <a:sy n="100" d="100"/>
        </p:scale>
        <p:origin x="-1746" y="-1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tilak.cc\share\Daten02\Urologie\Oncotyrol%202.3.3_Dr.Sch&#228;r\data\Plos%20One%20Revision_24h%2048h%20MCT%20treatment_19JUN2015.xl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Arbeitsordner\Publikationen\2015%20Dueregger%20MCTs%20in%20vitro\new%20data%20evaluation\Kopie%20von%20DuCaP%20Viability%20Assay%20Oils%20Auswertung%20n=3%202606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0555555555555555E-2"/>
          <c:y val="0.17653884366691591"/>
          <c:w val="0.66388888888888886"/>
          <c:h val="0.70632657271746901"/>
        </c:manualLayout>
      </c:layout>
      <c:barChart>
        <c:barDir val="col"/>
        <c:grouping val="clustered"/>
        <c:varyColors val="0"/>
        <c:ser>
          <c:idx val="0"/>
          <c:order val="0"/>
          <c:tx>
            <c:v>MCT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l Fig 24 h'!$B$4:$E$4</c:f>
                <c:numCache>
                  <c:formatCode>General</c:formatCode>
                  <c:ptCount val="4"/>
                  <c:pt idx="0">
                    <c:v>0.12070193354238826</c:v>
                  </c:pt>
                  <c:pt idx="1">
                    <c:v>1.3111757743369139E-2</c:v>
                  </c:pt>
                  <c:pt idx="2">
                    <c:v>2.8758104818521153E-2</c:v>
                  </c:pt>
                  <c:pt idx="3">
                    <c:v>2.8758104818521153E-2</c:v>
                  </c:pt>
                </c:numCache>
              </c:numRef>
            </c:plus>
            <c:minus>
              <c:numRef>
                <c:f>'Suppl Fig 24 h'!$B$4:$E$4</c:f>
                <c:numCache>
                  <c:formatCode>General</c:formatCode>
                  <c:ptCount val="4"/>
                  <c:pt idx="0">
                    <c:v>0.12070193354238826</c:v>
                  </c:pt>
                  <c:pt idx="1">
                    <c:v>1.3111757743369139E-2</c:v>
                  </c:pt>
                  <c:pt idx="2">
                    <c:v>2.8758104818521153E-2</c:v>
                  </c:pt>
                  <c:pt idx="3">
                    <c:v>2.8758104818521153E-2</c:v>
                  </c:pt>
                </c:numCache>
              </c:numRef>
            </c:minus>
          </c:errBars>
          <c:cat>
            <c:strRef>
              <c:f>'Suppl Fig 24 h'!$B$2:$E$2</c:f>
              <c:strCache>
                <c:ptCount val="4"/>
                <c:pt idx="0">
                  <c:v>RWPE1</c:v>
                </c:pt>
                <c:pt idx="1">
                  <c:v>LNCaP</c:v>
                </c:pt>
                <c:pt idx="2">
                  <c:v>ABL</c:v>
                </c:pt>
                <c:pt idx="3">
                  <c:v>PC3</c:v>
                </c:pt>
              </c:strCache>
            </c:strRef>
          </c:cat>
          <c:val>
            <c:numRef>
              <c:f>'Suppl Fig 24 h'!$B$3:$E$3</c:f>
              <c:numCache>
                <c:formatCode>General</c:formatCode>
                <c:ptCount val="4"/>
                <c:pt idx="0" formatCode="0.00">
                  <c:v>0.93505039193728989</c:v>
                </c:pt>
                <c:pt idx="1">
                  <c:v>0.99721835883171062</c:v>
                </c:pt>
                <c:pt idx="2" formatCode="0.00">
                  <c:v>0.94393099199014197</c:v>
                </c:pt>
                <c:pt idx="3" formatCode="0.00">
                  <c:v>0.94393099199014197</c:v>
                </c:pt>
              </c:numCache>
            </c:numRef>
          </c:val>
        </c:ser>
        <c:ser>
          <c:idx val="1"/>
          <c:order val="1"/>
          <c:tx>
            <c:v>w3</c:v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l Fig 24 h'!$I$4:$L$4</c:f>
                <c:numCache>
                  <c:formatCode>General</c:formatCode>
                  <c:ptCount val="4"/>
                  <c:pt idx="0">
                    <c:v>7.493601354679337E-2</c:v>
                  </c:pt>
                  <c:pt idx="1">
                    <c:v>4.7420659586181737E-3</c:v>
                  </c:pt>
                  <c:pt idx="2">
                    <c:v>7.6585353633124333E-3</c:v>
                  </c:pt>
                  <c:pt idx="3">
                    <c:v>7.6585353633124333E-3</c:v>
                  </c:pt>
                </c:numCache>
              </c:numRef>
            </c:plus>
            <c:minus>
              <c:numRef>
                <c:f>'Suppl Fig 24 h'!$I$4:$L$4</c:f>
                <c:numCache>
                  <c:formatCode>General</c:formatCode>
                  <c:ptCount val="4"/>
                  <c:pt idx="0">
                    <c:v>7.493601354679337E-2</c:v>
                  </c:pt>
                  <c:pt idx="1">
                    <c:v>4.7420659586181737E-3</c:v>
                  </c:pt>
                  <c:pt idx="2">
                    <c:v>7.6585353633124333E-3</c:v>
                  </c:pt>
                  <c:pt idx="3">
                    <c:v>7.6585353633124333E-3</c:v>
                  </c:pt>
                </c:numCache>
              </c:numRef>
            </c:minus>
          </c:errBars>
          <c:val>
            <c:numRef>
              <c:f>'Suppl Fig 24 h'!$I$3:$L$3</c:f>
              <c:numCache>
                <c:formatCode>General</c:formatCode>
                <c:ptCount val="4"/>
                <c:pt idx="0" formatCode="0.00">
                  <c:v>1.2777155655095185</c:v>
                </c:pt>
                <c:pt idx="1">
                  <c:v>1.0086926286509039</c:v>
                </c:pt>
                <c:pt idx="2" formatCode="0.00">
                  <c:v>1.0286506469500927</c:v>
                </c:pt>
                <c:pt idx="3" formatCode="0.00">
                  <c:v>1.0286506469500927</c:v>
                </c:pt>
              </c:numCache>
            </c:numRef>
          </c:val>
        </c:ser>
        <c:ser>
          <c:idx val="2"/>
          <c:order val="2"/>
          <c:tx>
            <c:v>MCT+w3</c:v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l Fig 24 h'!$B$8:$E$8</c:f>
                <c:numCache>
                  <c:formatCode>General</c:formatCode>
                  <c:ptCount val="4"/>
                  <c:pt idx="0">
                    <c:v>7.2069845060264634E-2</c:v>
                  </c:pt>
                  <c:pt idx="1">
                    <c:v>1.9539668036477234E-2</c:v>
                  </c:pt>
                  <c:pt idx="2">
                    <c:v>1.3694461349903198E-2</c:v>
                  </c:pt>
                  <c:pt idx="3">
                    <c:v>1.3694461349903198E-2</c:v>
                  </c:pt>
                </c:numCache>
              </c:numRef>
            </c:plus>
            <c:minus>
              <c:numRef>
                <c:f>'Suppl Fig 24 h'!$B$8:$E$8</c:f>
                <c:numCache>
                  <c:formatCode>General</c:formatCode>
                  <c:ptCount val="4"/>
                  <c:pt idx="0">
                    <c:v>7.2069845060264634E-2</c:v>
                  </c:pt>
                  <c:pt idx="1">
                    <c:v>1.9539668036477234E-2</c:v>
                  </c:pt>
                  <c:pt idx="2">
                    <c:v>1.3694461349903198E-2</c:v>
                  </c:pt>
                  <c:pt idx="3">
                    <c:v>1.3694461349903198E-2</c:v>
                  </c:pt>
                </c:numCache>
              </c:numRef>
            </c:minus>
          </c:errBars>
          <c:val>
            <c:numRef>
              <c:f>'Suppl Fig 24 h'!$B$7:$E$7</c:f>
              <c:numCache>
                <c:formatCode>General</c:formatCode>
                <c:ptCount val="4"/>
                <c:pt idx="0" formatCode="0.00">
                  <c:v>1.1108622620380739</c:v>
                </c:pt>
                <c:pt idx="1">
                  <c:v>1.0073018080667593</c:v>
                </c:pt>
                <c:pt idx="2">
                  <c:v>0.98367221195317334</c:v>
                </c:pt>
                <c:pt idx="3" formatCode="0.00">
                  <c:v>0.98367221195317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95296"/>
        <c:axId val="82696832"/>
      </c:barChart>
      <c:catAx>
        <c:axId val="82695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de-DE"/>
          </a:p>
        </c:txPr>
        <c:crossAx val="82696832"/>
        <c:crosses val="autoZero"/>
        <c:auto val="1"/>
        <c:lblAlgn val="ctr"/>
        <c:lblOffset val="100"/>
        <c:noMultiLvlLbl val="0"/>
      </c:catAx>
      <c:valAx>
        <c:axId val="82696832"/>
        <c:scaling>
          <c:orientation val="minMax"/>
          <c:max val="1.4"/>
        </c:scaling>
        <c:delete val="0"/>
        <c:axPos val="l"/>
        <c:numFmt formatCode="0.00" sourceLinked="1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82695296"/>
        <c:crosses val="autoZero"/>
        <c:crossBetween val="between"/>
        <c:majorUnit val="0.2"/>
        <c:minorUnit val="4.0000000000000008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5267286239495155"/>
          <c:y val="0.19580183183914468"/>
        </c:manualLayout>
      </c:layout>
      <c:overlay val="0"/>
      <c:txPr>
        <a:bodyPr/>
        <a:lstStyle/>
        <a:p>
          <a:pPr>
            <a:defRPr sz="12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M$9</c:f>
              <c:strCache>
                <c:ptCount val="1"/>
                <c:pt idx="0">
                  <c:v>DuCaP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Tabelle1!$O$9,Tabelle1!$Q$9,Tabelle1!$S$9)</c:f>
                <c:numCache>
                  <c:formatCode>General</c:formatCode>
                  <c:ptCount val="3"/>
                  <c:pt idx="0">
                    <c:v>5.9558787330000369E-2</c:v>
                  </c:pt>
                  <c:pt idx="1">
                    <c:v>3.9041162313340136E-2</c:v>
                  </c:pt>
                  <c:pt idx="2">
                    <c:v>9.804596734963928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Tabelle1!$N$2,Tabelle1!$P$2,Tabelle1!$R$2)</c:f>
              <c:strCache>
                <c:ptCount val="3"/>
                <c:pt idx="0">
                  <c:v>MCT</c:v>
                </c:pt>
                <c:pt idx="1">
                  <c:v>LCT</c:v>
                </c:pt>
                <c:pt idx="2">
                  <c:v>MCT/LCT</c:v>
                </c:pt>
              </c:strCache>
            </c:strRef>
          </c:cat>
          <c:val>
            <c:numRef>
              <c:f>(Tabelle1!$N$9,Tabelle1!$P$9,Tabelle1!$R$9)</c:f>
              <c:numCache>
                <c:formatCode>0.00</c:formatCode>
                <c:ptCount val="3"/>
                <c:pt idx="0">
                  <c:v>1.1279391424619643</c:v>
                </c:pt>
                <c:pt idx="1">
                  <c:v>1.0096818810511756</c:v>
                </c:pt>
                <c:pt idx="2">
                  <c:v>1.03319502074688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578048"/>
        <c:axId val="82628992"/>
      </c:barChart>
      <c:catAx>
        <c:axId val="82578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de-DE"/>
          </a:p>
        </c:txPr>
        <c:crossAx val="82628992"/>
        <c:crosses val="autoZero"/>
        <c:auto val="1"/>
        <c:lblAlgn val="ctr"/>
        <c:lblOffset val="100"/>
        <c:noMultiLvlLbl val="0"/>
      </c:catAx>
      <c:valAx>
        <c:axId val="82628992"/>
        <c:scaling>
          <c:orientation val="minMax"/>
          <c:max val="2.5"/>
        </c:scaling>
        <c:delete val="1"/>
        <c:axPos val="l"/>
        <c:numFmt formatCode="0.0" sourceLinked="0"/>
        <c:majorTickMark val="out"/>
        <c:minorTickMark val="none"/>
        <c:tickLblPos val="nextTo"/>
        <c:crossAx val="825780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4582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3041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2905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1266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812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919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477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473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0732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0279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3234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D75D2-EE3A-4073-B5CC-A284D48421E3}" type="datetimeFigureOut">
              <a:rPr lang="de-DE" smtClean="0"/>
              <a:t>07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51A92-1013-4923-9C5A-C27E82DE0D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3024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40"/>
          <p:cNvSpPr txBox="1">
            <a:spLocks noChangeArrowheads="1"/>
          </p:cNvSpPr>
          <p:nvPr/>
        </p:nvSpPr>
        <p:spPr bwMode="auto">
          <a:xfrm>
            <a:off x="139494" y="342048"/>
            <a:ext cx="33605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AT" alt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de-AT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de-AT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eregger et </a:t>
            </a:r>
            <a:r>
              <a:rPr lang="de-AT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endParaRPr lang="de-DE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" name="Gruppieren 42"/>
          <p:cNvGrpSpPr/>
          <p:nvPr/>
        </p:nvGrpSpPr>
        <p:grpSpPr>
          <a:xfrm>
            <a:off x="204179" y="776702"/>
            <a:ext cx="5208983" cy="2733676"/>
            <a:chOff x="34213" y="273313"/>
            <a:chExt cx="5208983" cy="2733676"/>
          </a:xfrm>
        </p:grpSpPr>
        <p:graphicFrame>
          <p:nvGraphicFramePr>
            <p:cNvPr id="25" name="Diagramm 2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67791216"/>
                </p:ext>
              </p:extLst>
            </p:nvPr>
          </p:nvGraphicFramePr>
          <p:xfrm>
            <a:off x="671196" y="273313"/>
            <a:ext cx="4572000" cy="27336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 Box 22"/>
            <p:cNvSpPr txBox="1">
              <a:spLocks noChangeArrowheads="1"/>
            </p:cNvSpPr>
            <p:nvPr/>
          </p:nvSpPr>
          <p:spPr bwMode="auto">
            <a:xfrm rot="16200000">
              <a:off x="-642979" y="1534295"/>
              <a:ext cx="19779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cell viability</a:t>
              </a: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570782" y="2546614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66588" y="1706927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66588" y="1445317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72386" y="1159085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466588" y="897475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466588" y="620237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4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466588" y="2000010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466588" y="2279176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de-DE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9" name="Gruppieren 4"/>
            <p:cNvGrpSpPr>
              <a:grpSpLocks/>
            </p:cNvGrpSpPr>
            <p:nvPr/>
          </p:nvGrpSpPr>
          <p:grpSpPr bwMode="auto">
            <a:xfrm>
              <a:off x="2411760" y="397206"/>
              <a:ext cx="1417653" cy="707886"/>
              <a:chOff x="5381596" y="1196975"/>
              <a:chExt cx="1338953" cy="708242"/>
            </a:xfrm>
          </p:grpSpPr>
          <p:sp>
            <p:nvSpPr>
              <p:cNvPr id="20" name="Rechteck 73"/>
              <p:cNvSpPr>
                <a:spLocks noChangeArrowheads="1"/>
              </p:cNvSpPr>
              <p:nvPr/>
            </p:nvSpPr>
            <p:spPr bwMode="auto">
              <a:xfrm>
                <a:off x="5381945" y="1299935"/>
                <a:ext cx="126159" cy="108054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 w="9525" algn="ctr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endParaRPr lang="de-DE" altLang="de-DE" sz="1000">
                  <a:latin typeface="Times New Roman" panose="02020603050405020304" pitchFamily="18" charset="0"/>
                  <a:ea typeface="ＭＳ Ｐゴシック" pitchFamily="1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Rechteck 41"/>
              <p:cNvSpPr>
                <a:spLocks noChangeArrowheads="1"/>
              </p:cNvSpPr>
              <p:nvPr/>
            </p:nvSpPr>
            <p:spPr bwMode="auto">
              <a:xfrm>
                <a:off x="5381596" y="1487493"/>
                <a:ext cx="126961" cy="108054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9525" algn="ctr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feld 42"/>
              <p:cNvSpPr txBox="1">
                <a:spLocks noChangeArrowheads="1"/>
              </p:cNvSpPr>
              <p:nvPr/>
            </p:nvSpPr>
            <p:spPr bwMode="auto">
              <a:xfrm>
                <a:off x="5521147" y="1196975"/>
                <a:ext cx="1199402" cy="7082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>
                  <a:lnSpc>
                    <a:spcPts val="1600"/>
                  </a:lnSpc>
                </a:pPr>
                <a:r>
                  <a:rPr lang="de-AT" altLang="de-DE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T (200 µM)</a:t>
                </a:r>
                <a:endParaRPr lang="de-AT" altLang="de-DE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eaLnBrk="1" hangingPunct="1">
                  <a:lnSpc>
                    <a:spcPts val="1600"/>
                  </a:lnSpc>
                </a:pPr>
                <a:r>
                  <a:rPr lang="en-GB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/>
                  </a:rPr>
                  <a:t>LCT</a:t>
                </a:r>
                <a:r>
                  <a:rPr lang="en-GB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200 µM</a:t>
                </a:r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lang="de-AT" altLang="de-DE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eaLnBrk="1" hangingPunct="1">
                  <a:lnSpc>
                    <a:spcPts val="1600"/>
                  </a:lnSpc>
                </a:pPr>
                <a:r>
                  <a:rPr lang="de-AT" altLang="de-DE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T/LCT </a:t>
                </a:r>
                <a:r>
                  <a:rPr lang="en-GB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200 µM)</a:t>
                </a:r>
                <a:endParaRPr lang="de-DE" altLang="de-DE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Rechteck 41"/>
              <p:cNvSpPr>
                <a:spLocks noChangeArrowheads="1"/>
              </p:cNvSpPr>
              <p:nvPr/>
            </p:nvSpPr>
            <p:spPr bwMode="auto">
              <a:xfrm>
                <a:off x="5381596" y="1675051"/>
                <a:ext cx="126961" cy="108054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 algn="ctr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4" name="Rechteck 23"/>
            <p:cNvSpPr/>
            <p:nvPr/>
          </p:nvSpPr>
          <p:spPr>
            <a:xfrm>
              <a:off x="2312730" y="397206"/>
              <a:ext cx="1439090" cy="66364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34213" y="273313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26" name="Diagramm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8161684"/>
              </p:ext>
            </p:extLst>
          </p:nvPr>
        </p:nvGraphicFramePr>
        <p:xfrm>
          <a:off x="5356048" y="722570"/>
          <a:ext cx="1649954" cy="31948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4502989" y="807476"/>
            <a:ext cx="287313" cy="3226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5" name="Gruppieren 34"/>
          <p:cNvGrpSpPr/>
          <p:nvPr/>
        </p:nvGrpSpPr>
        <p:grpSpPr>
          <a:xfrm>
            <a:off x="5434571" y="1352506"/>
            <a:ext cx="69508" cy="1899329"/>
            <a:chOff x="5317046" y="1095375"/>
            <a:chExt cx="81905" cy="1630839"/>
          </a:xfrm>
        </p:grpSpPr>
        <p:grpSp>
          <p:nvGrpSpPr>
            <p:cNvPr id="34" name="Gruppieren 33"/>
            <p:cNvGrpSpPr/>
            <p:nvPr/>
          </p:nvGrpSpPr>
          <p:grpSpPr>
            <a:xfrm>
              <a:off x="5329039" y="1095375"/>
              <a:ext cx="62111" cy="1630839"/>
              <a:chOff x="4860032" y="3429000"/>
              <a:chExt cx="72008" cy="1609712"/>
            </a:xfrm>
          </p:grpSpPr>
          <p:cxnSp>
            <p:nvCxnSpPr>
              <p:cNvPr id="14" name="Gerade Verbindung 13"/>
              <p:cNvCxnSpPr/>
              <p:nvPr/>
            </p:nvCxnSpPr>
            <p:spPr>
              <a:xfrm flipV="1">
                <a:off x="4932040" y="3429000"/>
                <a:ext cx="0" cy="16097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 Verbindung 27"/>
              <p:cNvCxnSpPr/>
              <p:nvPr/>
            </p:nvCxnSpPr>
            <p:spPr>
              <a:xfrm>
                <a:off x="4860032" y="3429000"/>
                <a:ext cx="720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 Verbindung 28"/>
              <p:cNvCxnSpPr/>
              <p:nvPr/>
            </p:nvCxnSpPr>
            <p:spPr>
              <a:xfrm>
                <a:off x="4860032" y="4979268"/>
                <a:ext cx="720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0" name="Gerade Verbindung 29"/>
            <p:cNvCxnSpPr/>
            <p:nvPr/>
          </p:nvCxnSpPr>
          <p:spPr>
            <a:xfrm>
              <a:off x="5317046" y="1411170"/>
              <a:ext cx="720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 Verbindung 30"/>
            <p:cNvCxnSpPr/>
            <p:nvPr/>
          </p:nvCxnSpPr>
          <p:spPr>
            <a:xfrm>
              <a:off x="5317046" y="1725977"/>
              <a:ext cx="720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31"/>
            <p:cNvCxnSpPr/>
            <p:nvPr/>
          </p:nvCxnSpPr>
          <p:spPr>
            <a:xfrm>
              <a:off x="5324661" y="2038110"/>
              <a:ext cx="720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 Verbindung 32"/>
            <p:cNvCxnSpPr/>
            <p:nvPr/>
          </p:nvCxnSpPr>
          <p:spPr>
            <a:xfrm>
              <a:off x="5326943" y="2352831"/>
              <a:ext cx="720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feld 35"/>
          <p:cNvSpPr txBox="1"/>
          <p:nvPr/>
        </p:nvSpPr>
        <p:spPr>
          <a:xfrm>
            <a:off x="5254530" y="3029356"/>
            <a:ext cx="216573" cy="304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5172609" y="2668931"/>
            <a:ext cx="306358" cy="304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5172609" y="2309933"/>
            <a:ext cx="306358" cy="304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165229" y="1934958"/>
            <a:ext cx="306358" cy="304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de-A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172609" y="1207065"/>
            <a:ext cx="306358" cy="304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de-A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5162888" y="1578854"/>
            <a:ext cx="306358" cy="304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 Box 22"/>
          <p:cNvSpPr txBox="1">
            <a:spLocks noChangeArrowheads="1"/>
          </p:cNvSpPr>
          <p:nvPr/>
        </p:nvSpPr>
        <p:spPr bwMode="auto">
          <a:xfrm rot="16200000">
            <a:off x="4050131" y="2104908"/>
            <a:ext cx="19779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cell viability</a:t>
            </a:r>
          </a:p>
        </p:txBody>
      </p:sp>
    </p:spTree>
    <p:extLst>
      <p:ext uri="{BB962C8B-B14F-4D97-AF65-F5344CB8AC3E}">
        <p14:creationId xmlns:p14="http://schemas.microsoft.com/office/powerpoint/2010/main" val="70793690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Bildschirmpräsentation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Tilak Gmb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allinger</dc:creator>
  <cp:lastModifiedBy>EDER Iris,Dr.</cp:lastModifiedBy>
  <cp:revision>52</cp:revision>
  <dcterms:created xsi:type="dcterms:W3CDTF">2015-06-19T11:03:37Z</dcterms:created>
  <dcterms:modified xsi:type="dcterms:W3CDTF">2015-07-07T09:15:06Z</dcterms:modified>
</cp:coreProperties>
</file>